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4500563" cy="5940425"/>
  <p:notesSz cx="6858000" cy="9144000"/>
  <p:defaultTextStyle>
    <a:defPPr>
      <a:defRPr lang="ko-KR"/>
    </a:defPPr>
    <a:lvl1pPr marL="0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1pPr>
    <a:lvl2pPr marL="227183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2pPr>
    <a:lvl3pPr marL="454365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3pPr>
    <a:lvl4pPr marL="681548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4pPr>
    <a:lvl5pPr marL="908731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5pPr>
    <a:lvl6pPr marL="1135913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6pPr>
    <a:lvl7pPr marL="1363096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7pPr>
    <a:lvl8pPr marL="1590279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8pPr>
    <a:lvl9pPr marL="1817461" algn="l" defTabSz="454365" rtl="0" eaLnBrk="1" latinLnBrk="1" hangingPunct="1">
      <a:defRPr sz="8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8" autoAdjust="0"/>
    <p:restoredTop sz="94660"/>
  </p:normalViewPr>
  <p:slideViewPr>
    <p:cSldViewPr snapToGrid="0">
      <p:cViewPr>
        <p:scale>
          <a:sx n="200" d="100"/>
          <a:sy n="200" d="100"/>
        </p:scale>
        <p:origin x="203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37542" y="972195"/>
            <a:ext cx="3825479" cy="2068148"/>
          </a:xfrm>
        </p:spPr>
        <p:txBody>
          <a:bodyPr anchor="b"/>
          <a:lstStyle>
            <a:lvl1pPr algn="ctr">
              <a:defRPr sz="295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62571" y="3120099"/>
            <a:ext cx="3375422" cy="1434227"/>
          </a:xfrm>
        </p:spPr>
        <p:txBody>
          <a:bodyPr/>
          <a:lstStyle>
            <a:lvl1pPr marL="0" indent="0" algn="ctr">
              <a:buNone/>
              <a:defRPr sz="1181"/>
            </a:lvl1pPr>
            <a:lvl2pPr marL="225034" indent="0" algn="ctr">
              <a:buNone/>
              <a:defRPr sz="984"/>
            </a:lvl2pPr>
            <a:lvl3pPr marL="450068" indent="0" algn="ctr">
              <a:buNone/>
              <a:defRPr sz="886"/>
            </a:lvl3pPr>
            <a:lvl4pPr marL="675102" indent="0" algn="ctr">
              <a:buNone/>
              <a:defRPr sz="788"/>
            </a:lvl4pPr>
            <a:lvl5pPr marL="900135" indent="0" algn="ctr">
              <a:buNone/>
              <a:defRPr sz="788"/>
            </a:lvl5pPr>
            <a:lvl6pPr marL="1125169" indent="0" algn="ctr">
              <a:buNone/>
              <a:defRPr sz="788"/>
            </a:lvl6pPr>
            <a:lvl7pPr marL="1350203" indent="0" algn="ctr">
              <a:buNone/>
              <a:defRPr sz="788"/>
            </a:lvl7pPr>
            <a:lvl8pPr marL="1575237" indent="0" algn="ctr">
              <a:buNone/>
              <a:defRPr sz="788"/>
            </a:lvl8pPr>
            <a:lvl9pPr marL="1800271" indent="0" algn="ctr">
              <a:buNone/>
              <a:defRPr sz="788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2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3032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20716" y="316272"/>
            <a:ext cx="970434" cy="503423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9414" y="316272"/>
            <a:ext cx="2855045" cy="503423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29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5742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7070" y="1480983"/>
            <a:ext cx="3881736" cy="2471051"/>
          </a:xfrm>
        </p:spPr>
        <p:txBody>
          <a:bodyPr anchor="b"/>
          <a:lstStyle>
            <a:lvl1pPr>
              <a:defRPr sz="295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7070" y="3975411"/>
            <a:ext cx="3881736" cy="1299468"/>
          </a:xfrm>
        </p:spPr>
        <p:txBody>
          <a:bodyPr/>
          <a:lstStyle>
            <a:lvl1pPr marL="0" indent="0">
              <a:buNone/>
              <a:defRPr sz="1181">
                <a:solidFill>
                  <a:schemeClr val="tx1"/>
                </a:solidFill>
              </a:defRPr>
            </a:lvl1pPr>
            <a:lvl2pPr marL="225034" indent="0">
              <a:buNone/>
              <a:defRPr sz="984">
                <a:solidFill>
                  <a:schemeClr val="tx1">
                    <a:tint val="75000"/>
                  </a:schemeClr>
                </a:solidFill>
              </a:defRPr>
            </a:lvl2pPr>
            <a:lvl3pPr marL="450068" indent="0">
              <a:buNone/>
              <a:defRPr sz="886">
                <a:solidFill>
                  <a:schemeClr val="tx1">
                    <a:tint val="75000"/>
                  </a:schemeClr>
                </a:solidFill>
              </a:defRPr>
            </a:lvl3pPr>
            <a:lvl4pPr marL="675102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4pPr>
            <a:lvl5pPr marL="90013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5pPr>
            <a:lvl6pPr marL="1125169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6pPr>
            <a:lvl7pPr marL="1350203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7pPr>
            <a:lvl8pPr marL="1575237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8pPr>
            <a:lvl9pPr marL="1800271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5794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9414" y="1581363"/>
            <a:ext cx="1912739" cy="376914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78410" y="1581363"/>
            <a:ext cx="1912739" cy="376914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791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000" y="316274"/>
            <a:ext cx="3881736" cy="1148208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0000" y="1456229"/>
            <a:ext cx="1903949" cy="713676"/>
          </a:xfrm>
        </p:spPr>
        <p:txBody>
          <a:bodyPr anchor="b"/>
          <a:lstStyle>
            <a:lvl1pPr marL="0" indent="0">
              <a:buNone/>
              <a:defRPr sz="1181" b="1"/>
            </a:lvl1pPr>
            <a:lvl2pPr marL="225034" indent="0">
              <a:buNone/>
              <a:defRPr sz="984" b="1"/>
            </a:lvl2pPr>
            <a:lvl3pPr marL="450068" indent="0">
              <a:buNone/>
              <a:defRPr sz="886" b="1"/>
            </a:lvl3pPr>
            <a:lvl4pPr marL="675102" indent="0">
              <a:buNone/>
              <a:defRPr sz="788" b="1"/>
            </a:lvl4pPr>
            <a:lvl5pPr marL="900135" indent="0">
              <a:buNone/>
              <a:defRPr sz="788" b="1"/>
            </a:lvl5pPr>
            <a:lvl6pPr marL="1125169" indent="0">
              <a:buNone/>
              <a:defRPr sz="788" b="1"/>
            </a:lvl6pPr>
            <a:lvl7pPr marL="1350203" indent="0">
              <a:buNone/>
              <a:defRPr sz="788" b="1"/>
            </a:lvl7pPr>
            <a:lvl8pPr marL="1575237" indent="0">
              <a:buNone/>
              <a:defRPr sz="788" b="1"/>
            </a:lvl8pPr>
            <a:lvl9pPr marL="1800271" indent="0">
              <a:buNone/>
              <a:defRPr sz="7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000" y="2169905"/>
            <a:ext cx="1903949" cy="319160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278411" y="1456229"/>
            <a:ext cx="1913325" cy="713676"/>
          </a:xfrm>
        </p:spPr>
        <p:txBody>
          <a:bodyPr anchor="b"/>
          <a:lstStyle>
            <a:lvl1pPr marL="0" indent="0">
              <a:buNone/>
              <a:defRPr sz="1181" b="1"/>
            </a:lvl1pPr>
            <a:lvl2pPr marL="225034" indent="0">
              <a:buNone/>
              <a:defRPr sz="984" b="1"/>
            </a:lvl2pPr>
            <a:lvl3pPr marL="450068" indent="0">
              <a:buNone/>
              <a:defRPr sz="886" b="1"/>
            </a:lvl3pPr>
            <a:lvl4pPr marL="675102" indent="0">
              <a:buNone/>
              <a:defRPr sz="788" b="1"/>
            </a:lvl4pPr>
            <a:lvl5pPr marL="900135" indent="0">
              <a:buNone/>
              <a:defRPr sz="788" b="1"/>
            </a:lvl5pPr>
            <a:lvl6pPr marL="1125169" indent="0">
              <a:buNone/>
              <a:defRPr sz="788" b="1"/>
            </a:lvl6pPr>
            <a:lvl7pPr marL="1350203" indent="0">
              <a:buNone/>
              <a:defRPr sz="788" b="1"/>
            </a:lvl7pPr>
            <a:lvl8pPr marL="1575237" indent="0">
              <a:buNone/>
              <a:defRPr sz="788" b="1"/>
            </a:lvl8pPr>
            <a:lvl9pPr marL="1800271" indent="0">
              <a:buNone/>
              <a:defRPr sz="788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278411" y="2169905"/>
            <a:ext cx="1913325" cy="319160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0513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1371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67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000" y="396028"/>
            <a:ext cx="1451549" cy="1386099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13325" y="855313"/>
            <a:ext cx="2278410" cy="4221552"/>
          </a:xfrm>
        </p:spPr>
        <p:txBody>
          <a:bodyPr/>
          <a:lstStyle>
            <a:lvl1pPr>
              <a:defRPr sz="1575"/>
            </a:lvl1pPr>
            <a:lvl2pPr>
              <a:defRPr sz="1378"/>
            </a:lvl2pPr>
            <a:lvl3pPr>
              <a:defRPr sz="1181"/>
            </a:lvl3pPr>
            <a:lvl4pPr>
              <a:defRPr sz="984"/>
            </a:lvl4pPr>
            <a:lvl5pPr>
              <a:defRPr sz="984"/>
            </a:lvl5pPr>
            <a:lvl6pPr>
              <a:defRPr sz="984"/>
            </a:lvl6pPr>
            <a:lvl7pPr>
              <a:defRPr sz="984"/>
            </a:lvl7pPr>
            <a:lvl8pPr>
              <a:defRPr sz="984"/>
            </a:lvl8pPr>
            <a:lvl9pPr>
              <a:defRPr sz="98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0000" y="1782127"/>
            <a:ext cx="1451549" cy="3301612"/>
          </a:xfrm>
        </p:spPr>
        <p:txBody>
          <a:bodyPr/>
          <a:lstStyle>
            <a:lvl1pPr marL="0" indent="0">
              <a:buNone/>
              <a:defRPr sz="788"/>
            </a:lvl1pPr>
            <a:lvl2pPr marL="225034" indent="0">
              <a:buNone/>
              <a:defRPr sz="689"/>
            </a:lvl2pPr>
            <a:lvl3pPr marL="450068" indent="0">
              <a:buNone/>
              <a:defRPr sz="591"/>
            </a:lvl3pPr>
            <a:lvl4pPr marL="675102" indent="0">
              <a:buNone/>
              <a:defRPr sz="492"/>
            </a:lvl4pPr>
            <a:lvl5pPr marL="900135" indent="0">
              <a:buNone/>
              <a:defRPr sz="492"/>
            </a:lvl5pPr>
            <a:lvl6pPr marL="1125169" indent="0">
              <a:buNone/>
              <a:defRPr sz="492"/>
            </a:lvl6pPr>
            <a:lvl7pPr marL="1350203" indent="0">
              <a:buNone/>
              <a:defRPr sz="492"/>
            </a:lvl7pPr>
            <a:lvl8pPr marL="1575237" indent="0">
              <a:buNone/>
              <a:defRPr sz="492"/>
            </a:lvl8pPr>
            <a:lvl9pPr marL="1800271" indent="0">
              <a:buNone/>
              <a:defRPr sz="492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26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0000" y="396028"/>
            <a:ext cx="1451549" cy="1386099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13325" y="855313"/>
            <a:ext cx="2278410" cy="4221552"/>
          </a:xfrm>
        </p:spPr>
        <p:txBody>
          <a:bodyPr anchor="t"/>
          <a:lstStyle>
            <a:lvl1pPr marL="0" indent="0">
              <a:buNone/>
              <a:defRPr sz="1575"/>
            </a:lvl1pPr>
            <a:lvl2pPr marL="225034" indent="0">
              <a:buNone/>
              <a:defRPr sz="1378"/>
            </a:lvl2pPr>
            <a:lvl3pPr marL="450068" indent="0">
              <a:buNone/>
              <a:defRPr sz="1181"/>
            </a:lvl3pPr>
            <a:lvl4pPr marL="675102" indent="0">
              <a:buNone/>
              <a:defRPr sz="984"/>
            </a:lvl4pPr>
            <a:lvl5pPr marL="900135" indent="0">
              <a:buNone/>
              <a:defRPr sz="984"/>
            </a:lvl5pPr>
            <a:lvl6pPr marL="1125169" indent="0">
              <a:buNone/>
              <a:defRPr sz="984"/>
            </a:lvl6pPr>
            <a:lvl7pPr marL="1350203" indent="0">
              <a:buNone/>
              <a:defRPr sz="984"/>
            </a:lvl7pPr>
            <a:lvl8pPr marL="1575237" indent="0">
              <a:buNone/>
              <a:defRPr sz="984"/>
            </a:lvl8pPr>
            <a:lvl9pPr marL="1800271" indent="0">
              <a:buNone/>
              <a:defRPr sz="984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0000" y="1782127"/>
            <a:ext cx="1451549" cy="3301612"/>
          </a:xfrm>
        </p:spPr>
        <p:txBody>
          <a:bodyPr/>
          <a:lstStyle>
            <a:lvl1pPr marL="0" indent="0">
              <a:buNone/>
              <a:defRPr sz="788"/>
            </a:lvl1pPr>
            <a:lvl2pPr marL="225034" indent="0">
              <a:buNone/>
              <a:defRPr sz="689"/>
            </a:lvl2pPr>
            <a:lvl3pPr marL="450068" indent="0">
              <a:buNone/>
              <a:defRPr sz="591"/>
            </a:lvl3pPr>
            <a:lvl4pPr marL="675102" indent="0">
              <a:buNone/>
              <a:defRPr sz="492"/>
            </a:lvl4pPr>
            <a:lvl5pPr marL="900135" indent="0">
              <a:buNone/>
              <a:defRPr sz="492"/>
            </a:lvl5pPr>
            <a:lvl6pPr marL="1125169" indent="0">
              <a:buNone/>
              <a:defRPr sz="492"/>
            </a:lvl6pPr>
            <a:lvl7pPr marL="1350203" indent="0">
              <a:buNone/>
              <a:defRPr sz="492"/>
            </a:lvl7pPr>
            <a:lvl8pPr marL="1575237" indent="0">
              <a:buNone/>
              <a:defRPr sz="492"/>
            </a:lvl8pPr>
            <a:lvl9pPr marL="1800271" indent="0">
              <a:buNone/>
              <a:defRPr sz="492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617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9414" y="316274"/>
            <a:ext cx="3881736" cy="11482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9414" y="1581363"/>
            <a:ext cx="3881736" cy="37691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9414" y="5505895"/>
            <a:ext cx="1012627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D0776-E50E-4C2F-BE6C-395E6E359983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90812" y="5505895"/>
            <a:ext cx="1518940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178522" y="5505895"/>
            <a:ext cx="1012627" cy="3162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3788F-0A4E-4671-BCD1-39D172B268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531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450068" rtl="0" eaLnBrk="1" latinLnBrk="1" hangingPunct="1">
        <a:lnSpc>
          <a:spcPct val="90000"/>
        </a:lnSpc>
        <a:spcBef>
          <a:spcPct val="0"/>
        </a:spcBef>
        <a:buNone/>
        <a:defRPr sz="21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2517" indent="-112517" algn="l" defTabSz="450068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1pPr>
      <a:lvl2pPr marL="337551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2pPr>
      <a:lvl3pPr marL="562585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984" kern="1200">
          <a:solidFill>
            <a:schemeClr val="tx1"/>
          </a:solidFill>
          <a:latin typeface="+mn-lt"/>
          <a:ea typeface="+mn-ea"/>
          <a:cs typeface="+mn-cs"/>
        </a:defRPr>
      </a:lvl3pPr>
      <a:lvl4pPr marL="787618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4pPr>
      <a:lvl5pPr marL="1012652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5pPr>
      <a:lvl6pPr marL="1237686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6pPr>
      <a:lvl7pPr marL="1462720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7pPr>
      <a:lvl8pPr marL="1687754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8pPr>
      <a:lvl9pPr marL="1912788" indent="-112517" algn="l" defTabSz="450068" rtl="0" eaLnBrk="1" latinLnBrk="1" hangingPunct="1">
        <a:lnSpc>
          <a:spcPct val="90000"/>
        </a:lnSpc>
        <a:spcBef>
          <a:spcPts val="246"/>
        </a:spcBef>
        <a:buFont typeface="Arial" panose="020B0604020202020204" pitchFamily="34" charset="0"/>
        <a:buChar char="•"/>
        <a:defRPr sz="88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1pPr>
      <a:lvl2pPr marL="225034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2pPr>
      <a:lvl3pPr marL="450068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3pPr>
      <a:lvl4pPr marL="675102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4pPr>
      <a:lvl5pPr marL="900135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5pPr>
      <a:lvl6pPr marL="1125169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6pPr>
      <a:lvl7pPr marL="1350203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7pPr>
      <a:lvl8pPr marL="1575237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8pPr>
      <a:lvl9pPr marL="1800271" algn="l" defTabSz="450068" rtl="0" eaLnBrk="1" latinLnBrk="1" hangingPunct="1">
        <a:defRPr sz="88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/>
          <p:cNvSpPr/>
          <p:nvPr/>
        </p:nvSpPr>
        <p:spPr>
          <a:xfrm>
            <a:off x="0" y="0"/>
            <a:ext cx="6229937" cy="4643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80"/>
              </a:spcAft>
            </a:pP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Chr8:48,877,987-48,879,365</a:t>
            </a:r>
            <a:endParaRPr lang="ko-KR" altLang="ko-KR" sz="8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80"/>
              </a:spcAft>
            </a:pP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Top</a:t>
            </a:r>
            <a:r>
              <a:rPr lang="en-US" altLang="ko-KR" sz="8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: normal sample, 350X. </a:t>
            </a: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Bottom</a:t>
            </a:r>
            <a:r>
              <a:rPr lang="en-US" altLang="ko-KR" sz="8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: tumor sample, 150X (non-clipped reads) + 100X (clipped reads).</a:t>
            </a:r>
            <a:endParaRPr lang="ko-KR" altLang="ko-KR" sz="8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14" name="그림 13" descr="C:\Users\admin\Desktop\R2 figure 1.pn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04"/>
          <a:stretch/>
        </p:blipFill>
        <p:spPr bwMode="auto">
          <a:xfrm>
            <a:off x="60297" y="460748"/>
            <a:ext cx="4342130" cy="24199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5" name="직사각형 14"/>
          <p:cNvSpPr/>
          <p:nvPr/>
        </p:nvSpPr>
        <p:spPr>
          <a:xfrm>
            <a:off x="0" y="2991423"/>
            <a:ext cx="5338762" cy="4515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Chr8:121,815,027-121,815,715</a:t>
            </a:r>
            <a:endParaRPr lang="ko-KR" altLang="ko-KR" sz="8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Top</a:t>
            </a:r>
            <a:r>
              <a:rPr lang="en-US" altLang="ko-KR" sz="8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: normal sample, 0X (intron). </a:t>
            </a:r>
            <a:r>
              <a:rPr lang="en-US" altLang="ko-KR" sz="8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Bottom</a:t>
            </a:r>
            <a:r>
              <a:rPr lang="en-US" altLang="ko-KR" sz="8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: tumor sample, 75X (derived by the gene fusion)</a:t>
            </a:r>
            <a:endParaRPr lang="ko-KR" altLang="ko-KR" sz="8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16" name="그림 15" descr="C:\Users\admin\Desktop\F1 figure.pn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03"/>
          <a:stretch/>
        </p:blipFill>
        <p:spPr bwMode="auto">
          <a:xfrm>
            <a:off x="50772" y="3442957"/>
            <a:ext cx="4351655" cy="24199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172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7</Words>
  <Application>Microsoft Office PowerPoint</Application>
  <PresentationFormat>사용자 지정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1</cp:revision>
  <dcterms:created xsi:type="dcterms:W3CDTF">2017-04-10T15:42:33Z</dcterms:created>
  <dcterms:modified xsi:type="dcterms:W3CDTF">2017-04-10T15:47:51Z</dcterms:modified>
</cp:coreProperties>
</file>